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934B56-A251-403E-BC56-F22A4B270837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254D86-B8A9-46ED-A977-27EF73A508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105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C-MS analysis of the extract of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elezensi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R-01.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08.66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22.67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36.69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50.71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44.65, 1058.67 and 1100.72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72.68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G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86.70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H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463.79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I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477.81 and 1491.82. (A, B, C, D) =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rfacti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(E, F, G) =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turi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(H, I) =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engyci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254D86-B8A9-46ED-A977-27EF73A5089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10591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254D86-B8A9-46ED-A977-27EF73A5089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36682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48FE5F-C268-D708-D962-A71D0AD712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CF6B119-E1E3-093F-B86E-993698B410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CEBFDA-0071-AA4A-0850-9DE76442D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09B354-43B2-F52A-39A4-1C282E855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22EAC5-FC1E-7BB7-6516-FDBB67284D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1116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C53869-B251-AE61-F086-DD66928531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1D3B74F-4295-7BBA-2A99-E70084479C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2EC3AD-EA71-C106-4593-C117BA440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0B91A1-BE23-95AB-DAE7-5E430DF36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901495-F435-FB39-0DD2-475C19CB2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822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C0E5063-50FE-2652-9B05-26FB214145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C58BE7-5298-82F4-525C-64A5CFD58E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AE725F-5459-FD4F-8172-7264092E6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D7041A-A26D-2AD9-B69C-D1D00F4DA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D5F3D4-5948-BA11-FCC8-689A5266A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224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42A251-C2B7-053F-9329-5DD1573772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6F46F32-15B1-DB32-FD8C-A07207F3C4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4241F4-2E4E-B8B0-CBEB-84137C15A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CA2D8F-D83A-B492-9E78-A45AA81E0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23B719-B6E8-3CE2-6EDA-DBFADCCF2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431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F83919-170E-E996-4E68-CE3DD67EAB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5D06153-2BB8-3722-145F-A5912896C8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81F226-47D4-1968-0C5D-1F5F76C4A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711953-BCA4-A328-E64C-640F7F5AE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E0FBFE-A70D-6A80-D793-07B4B8A16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58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AD5215-C03D-7EC2-767E-8BE46B581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C149AEE-0ECB-6007-783B-22A597C827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D774E26-B470-46B9-0277-26B359DAA0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AC10E1-52C2-275C-BE4B-653896EED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E269CEC-632D-33D7-8BC8-842F314FF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B0636AF-06D7-93DC-6B67-153588860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5743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0CAB26-8009-F2AD-027D-1DE2EC69CA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230BBD1-38A5-F69C-F73F-05877CB44C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63D5B6F-B519-1EA3-D699-45CE5F5124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D5040EA-F5D1-2279-7262-CD550A508D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CE744B3-1699-105E-3FC5-089BE0D7E4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6660AF9-34DB-816B-332C-BC040F500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3A28B86-363D-D5A4-964F-AE54FB5D0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A8CDE38-52E2-1292-A789-06FEC36F7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2911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DCCD15-72D0-9EE1-E42D-9B290DC69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C41901E-C2DE-D937-0D41-3999C1992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3301B13-E704-B583-B087-88A0A748F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E96921F-F39A-C714-062A-B65C9DE25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6600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C7CF733-F872-175F-38FB-50F18E07D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5948E5B-1984-02A2-6852-B010DCA23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427E128-FE0D-E8E3-73E1-F1BEE6F82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7150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0DECE4-89C1-A90B-6211-58E44C96E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451EC07-EA5A-2821-404D-30E03B7657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EB1B1C9-2BF6-EDA7-CCD5-87CF0B329D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FDC9B8-5C2D-BCBB-ED76-F26D518B1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1D9946-5F6C-2BBD-D1E3-E177E423B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E4E1293-614C-5544-496A-24B2F3754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783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82CE8C-B7D7-AFE5-8443-82782945F3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55E79AE-613D-0FA7-B949-396D2657F2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D2FEB97-A3CB-6B5E-6B71-054EF91D5D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9D8C1F-FD92-E131-344E-8B68348C8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AC6309-FF61-1D66-0765-0D5D43F70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941041C-FF1D-0CED-BE0B-93295F005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221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F932A8C-2F35-AFFE-AA97-89A70DB1C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6D71EFE-81D7-8901-9AE6-D8F6FC2366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254911-2EE0-7BCC-127F-AA0D575316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25B7A-7565-4A8D-8491-E12E94B0C525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D634C3-702E-97F9-6119-27F52A334E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94343D1-6539-700D-4435-DD9992AE6E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C88F6-BEE5-4B07-A7BC-F4686E63DB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1074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C747089-FF53-2256-7F9D-47A26396AB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8510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BC5DB446-004B-1961-C58C-A68D28D389E9}"/>
              </a:ext>
            </a:extLst>
          </p:cNvPr>
          <p:cNvSpPr txBox="1"/>
          <p:nvPr/>
        </p:nvSpPr>
        <p:spPr>
          <a:xfrm>
            <a:off x="1498862" y="1381646"/>
            <a:ext cx="9285402" cy="21253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C-MS analysis of the extract of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elezensi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R-01.</a:t>
            </a:r>
          </a:p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08.66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22.67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36.69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50.71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44.65, 1058.67 and 1100.72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72.68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G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086.70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H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463.79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I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S spectra of m/z 1477.81 and 1491.82. (A, B, C, D) =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rfacti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(E, F, G) =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turi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(H, I) =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engyci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2028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01</Words>
  <Application>Microsoft Office PowerPoint</Application>
  <PresentationFormat>宽屏</PresentationFormat>
  <Paragraphs>5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 Yong-Qiang</dc:creator>
  <cp:lastModifiedBy>He Yong-Qiang</cp:lastModifiedBy>
  <cp:revision>1</cp:revision>
  <dcterms:created xsi:type="dcterms:W3CDTF">2022-08-14T09:41:54Z</dcterms:created>
  <dcterms:modified xsi:type="dcterms:W3CDTF">2022-08-14T09:44:24Z</dcterms:modified>
</cp:coreProperties>
</file>